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E386E9-C47E-463B-B86F-5CA7220D3FE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EB6508-46E4-4C01-A4BF-9EEC4E8A66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3413FA-FC55-4F55-907B-C1BEB89B39A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C30B3C-2462-4EDB-BC0D-598E7EB3586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1864A5-F110-40F9-A8C7-72145758B09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04D974-A1BD-49BF-AE82-C1044353A91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4F5875-023A-45DC-AE7B-A88906F6364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1183CA-EB5D-4C8B-A228-44837441A96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8EC36C-D8C2-449E-A2A2-3FEB83126D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6C1C81-A5EE-4B33-A674-8884821EC4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1E80C3-EFB0-4A59-9CC7-B3BA2DAC95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F5C5E6-1C11-4C61-B339-FE4636965B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9A72E83-4F63-4D41-9392-20F7E9133FF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519120" y="2743200"/>
            <a:ext cx="2604960" cy="1830240"/>
            <a:chOff x="519120" y="2743200"/>
            <a:chExt cx="2604960" cy="1830240"/>
          </a:xfrm>
        </p:grpSpPr>
        <p:pic>
          <p:nvPicPr>
            <p:cNvPr id="42" name="" descr=""/>
            <p:cNvPicPr/>
            <p:nvPr/>
          </p:nvPicPr>
          <p:blipFill>
            <a:blip r:embed="rId1"/>
            <a:stretch/>
          </p:blipFill>
          <p:spPr>
            <a:xfrm>
              <a:off x="519120" y="2743200"/>
              <a:ext cx="2604960" cy="1830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"/>
            <p:cNvSpPr/>
            <p:nvPr/>
          </p:nvSpPr>
          <p:spPr>
            <a:xfrm>
              <a:off x="2119680" y="3962520"/>
              <a:ext cx="700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9 gen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4" name=""/>
          <p:cNvGrpSpPr/>
          <p:nvPr/>
        </p:nvGrpSpPr>
        <p:grpSpPr>
          <a:xfrm>
            <a:off x="533520" y="685800"/>
            <a:ext cx="2604960" cy="1830240"/>
            <a:chOff x="533520" y="685800"/>
            <a:chExt cx="2604960" cy="1830240"/>
          </a:xfrm>
        </p:grpSpPr>
        <p:pic>
          <p:nvPicPr>
            <p:cNvPr id="45" name="" descr=""/>
            <p:cNvPicPr/>
            <p:nvPr/>
          </p:nvPicPr>
          <p:blipFill>
            <a:blip r:embed="rId2"/>
            <a:stretch/>
          </p:blipFill>
          <p:spPr>
            <a:xfrm>
              <a:off x="533520" y="685800"/>
              <a:ext cx="2604960" cy="1830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"/>
            <p:cNvSpPr/>
            <p:nvPr/>
          </p:nvSpPr>
          <p:spPr>
            <a:xfrm>
              <a:off x="2134080" y="1905120"/>
              <a:ext cx="700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9 gen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7" name=""/>
          <p:cNvGrpSpPr/>
          <p:nvPr/>
        </p:nvGrpSpPr>
        <p:grpSpPr>
          <a:xfrm>
            <a:off x="3338640" y="685800"/>
            <a:ext cx="2604960" cy="1830240"/>
            <a:chOff x="3338640" y="685800"/>
            <a:chExt cx="2604960" cy="1830240"/>
          </a:xfrm>
        </p:grpSpPr>
        <p:pic>
          <p:nvPicPr>
            <p:cNvPr id="48" name="" descr=""/>
            <p:cNvPicPr/>
            <p:nvPr/>
          </p:nvPicPr>
          <p:blipFill>
            <a:blip r:embed="rId3"/>
            <a:stretch/>
          </p:blipFill>
          <p:spPr>
            <a:xfrm>
              <a:off x="3338640" y="685800"/>
              <a:ext cx="2604960" cy="1830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"/>
            <p:cNvSpPr/>
            <p:nvPr/>
          </p:nvSpPr>
          <p:spPr>
            <a:xfrm>
              <a:off x="4937760" y="1905120"/>
              <a:ext cx="700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6 gen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0" name=""/>
          <p:cNvGrpSpPr/>
          <p:nvPr/>
        </p:nvGrpSpPr>
        <p:grpSpPr>
          <a:xfrm>
            <a:off x="3352680" y="2743200"/>
            <a:ext cx="2604960" cy="1830240"/>
            <a:chOff x="3352680" y="2743200"/>
            <a:chExt cx="2604960" cy="1830240"/>
          </a:xfrm>
        </p:grpSpPr>
        <p:pic>
          <p:nvPicPr>
            <p:cNvPr id="51" name="" descr=""/>
            <p:cNvPicPr/>
            <p:nvPr/>
          </p:nvPicPr>
          <p:blipFill>
            <a:blip r:embed="rId4"/>
            <a:stretch/>
          </p:blipFill>
          <p:spPr>
            <a:xfrm>
              <a:off x="3352680" y="2743200"/>
              <a:ext cx="2604960" cy="1830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"/>
            <p:cNvSpPr/>
            <p:nvPr/>
          </p:nvSpPr>
          <p:spPr>
            <a:xfrm>
              <a:off x="4953240" y="3962520"/>
              <a:ext cx="700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8 gen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3" name=""/>
          <p:cNvGrpSpPr/>
          <p:nvPr/>
        </p:nvGrpSpPr>
        <p:grpSpPr>
          <a:xfrm>
            <a:off x="533520" y="4876920"/>
            <a:ext cx="2604960" cy="1830240"/>
            <a:chOff x="533520" y="4876920"/>
            <a:chExt cx="2604960" cy="1830240"/>
          </a:xfrm>
        </p:grpSpPr>
        <p:pic>
          <p:nvPicPr>
            <p:cNvPr id="54" name="" descr=""/>
            <p:cNvPicPr/>
            <p:nvPr/>
          </p:nvPicPr>
          <p:blipFill>
            <a:blip r:embed="rId5"/>
            <a:stretch/>
          </p:blipFill>
          <p:spPr>
            <a:xfrm>
              <a:off x="533520" y="4876920"/>
              <a:ext cx="2604960" cy="1830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5" name=""/>
            <p:cNvSpPr/>
            <p:nvPr/>
          </p:nvSpPr>
          <p:spPr>
            <a:xfrm>
              <a:off x="2134080" y="6121440"/>
              <a:ext cx="700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7 gen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6" name=""/>
          <p:cNvSpPr/>
          <p:nvPr/>
        </p:nvSpPr>
        <p:spPr>
          <a:xfrm>
            <a:off x="146160" y="76320"/>
            <a:ext cx="1886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dditional file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30760" y="60948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30760" y="266688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230400" y="480060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126240" y="60948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126240" y="266688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52280" y="6829560"/>
            <a:ext cx="656928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he concordance of fold-changes between SYBR Green-based RT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rofiler PCR Array and microarray platforms was evaluated by regression analysis of fold differences in sample B compared to sample A. Data were normalized against POLR2A for RT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PCR Array.  Normalized data from the five microarrays was obtained from the database accessible from the MAQC website (www.fda.gov/nctr/science/centers/toxicoinformatics/maqc/index.htm). The sample B/sample A (B/A) fold changes (log2) for each gene common between RT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PCR Array and another platform were subjected to bivariate analysis. The dashed line on each graph represents the ideal slope of 1.0.  The solid lines show a linear regression fi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764640" y="822240"/>
            <a:ext cx="133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=0.95; Slope=0.6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3583800" y="822240"/>
            <a:ext cx="133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=0.94; Slope=0.7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764640" y="2879640"/>
            <a:ext cx="133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=0.90; Slope=0.6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3583800" y="2879640"/>
            <a:ext cx="133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=0.86; Slope=0.5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764640" y="5013360"/>
            <a:ext cx="133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=0.92; Slope=0.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5-04T15:54:40Z</dcterms:created>
  <dc:creator> </dc:creator>
  <dc:description/>
  <dc:language>en-US</dc:language>
  <cp:lastModifiedBy> </cp:lastModifiedBy>
  <dcterms:modified xsi:type="dcterms:W3CDTF">2008-07-02T19:38:19Z</dcterms:modified>
  <cp:revision>14</cp:revision>
  <dc:subject/>
  <dc:title>Slide 1</dc:title>
</cp:coreProperties>
</file>